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88" r:id="rId2"/>
  </p:sldIdLst>
  <p:sldSz cx="7315200" cy="457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40" userDrawn="1">
          <p15:clr>
            <a:srgbClr val="A4A3A4"/>
          </p15:clr>
        </p15:guide>
        <p15:guide id="2" pos="1872" userDrawn="1">
          <p15:clr>
            <a:srgbClr val="A4A3A4"/>
          </p15:clr>
        </p15:guide>
        <p15:guide id="3" orient="horz" pos="672" userDrawn="1">
          <p15:clr>
            <a:srgbClr val="A4A3A4"/>
          </p15:clr>
        </p15:guide>
        <p15:guide id="4" orient="horz" pos="2136" userDrawn="1">
          <p15:clr>
            <a:srgbClr val="A4A3A4"/>
          </p15:clr>
        </p15:guide>
        <p15:guide id="5" pos="2064" userDrawn="1">
          <p15:clr>
            <a:srgbClr val="A4A3A4"/>
          </p15:clr>
        </p15:guide>
        <p15:guide id="6" pos="504" userDrawn="1">
          <p15:clr>
            <a:srgbClr val="A4A3A4"/>
          </p15:clr>
        </p15:guide>
        <p15:guide id="7" orient="horz" pos="132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DB1C8"/>
    <a:srgbClr val="FF0000"/>
    <a:srgbClr val="7FD7F7"/>
    <a:srgbClr val="FF9999"/>
    <a:srgbClr val="6EBAD6"/>
    <a:srgbClr val="00B0F0"/>
    <a:srgbClr val="0066FF"/>
    <a:srgbClr val="660033"/>
    <a:srgbClr val="FFFFCC"/>
    <a:srgbClr val="99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306799F8-075E-4A3A-A7F6-7FBC6576F1A4}" styleName="Themed Style 2 - Accent 3">
    <a:tblBg>
      <a:fillRef idx="3">
        <a:schemeClr val="accent3"/>
      </a:fillRef>
      <a:effectRef idx="3">
        <a:schemeClr val="accent3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3">
                <a:tint val="50000"/>
              </a:schemeClr>
            </a:lnRef>
          </a:left>
          <a:right>
            <a:lnRef idx="1">
              <a:schemeClr val="accent3">
                <a:tint val="50000"/>
              </a:schemeClr>
            </a:lnRef>
          </a:right>
          <a:top>
            <a:lnRef idx="1">
              <a:schemeClr val="accent3">
                <a:tint val="50000"/>
              </a:schemeClr>
            </a:lnRef>
          </a:top>
          <a:bottom>
            <a:lnRef idx="1">
              <a:schemeClr val="accent3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21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912" y="96"/>
      </p:cViewPr>
      <p:guideLst>
        <p:guide orient="horz" pos="1440"/>
        <p:guide pos="1872"/>
        <p:guide orient="horz" pos="672"/>
        <p:guide orient="horz" pos="2136"/>
        <p:guide pos="2064"/>
        <p:guide pos="504"/>
        <p:guide orient="horz" pos="132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748242"/>
            <a:ext cx="5486400" cy="1591733"/>
          </a:xfrm>
        </p:spPr>
        <p:txBody>
          <a:bodyPr anchor="b"/>
          <a:lstStyle>
            <a:lvl1pPr algn="ctr"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2401359"/>
            <a:ext cx="5486400" cy="1103841"/>
          </a:xfrm>
        </p:spPr>
        <p:txBody>
          <a:bodyPr/>
          <a:lstStyle>
            <a:lvl1pPr marL="0" indent="0" algn="ctr">
              <a:buNone/>
              <a:defRPr sz="1440"/>
            </a:lvl1pPr>
            <a:lvl2pPr marL="274320" indent="0" algn="ctr">
              <a:buNone/>
              <a:defRPr sz="1200"/>
            </a:lvl2pPr>
            <a:lvl3pPr marL="548640" indent="0" algn="ctr">
              <a:buNone/>
              <a:defRPr sz="1080"/>
            </a:lvl3pPr>
            <a:lvl4pPr marL="822960" indent="0" algn="ctr">
              <a:buNone/>
              <a:defRPr sz="960"/>
            </a:lvl4pPr>
            <a:lvl5pPr marL="1097280" indent="0" algn="ctr">
              <a:buNone/>
              <a:defRPr sz="960"/>
            </a:lvl5pPr>
            <a:lvl6pPr marL="1371600" indent="0" algn="ctr">
              <a:buNone/>
              <a:defRPr sz="960"/>
            </a:lvl6pPr>
            <a:lvl7pPr marL="1645920" indent="0" algn="ctr">
              <a:buNone/>
              <a:defRPr sz="960"/>
            </a:lvl7pPr>
            <a:lvl8pPr marL="1920240" indent="0" algn="ctr">
              <a:buNone/>
              <a:defRPr sz="960"/>
            </a:lvl8pPr>
            <a:lvl9pPr marL="2194560" indent="0" algn="ctr">
              <a:buNone/>
              <a:defRPr sz="9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231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269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243417"/>
            <a:ext cx="1577340" cy="387455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243417"/>
            <a:ext cx="4640580" cy="387455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187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699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1139826"/>
            <a:ext cx="6309360" cy="1901825"/>
          </a:xfrm>
        </p:spPr>
        <p:txBody>
          <a:bodyPr anchor="b"/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3059642"/>
            <a:ext cx="6309360" cy="1000125"/>
          </a:xfrm>
        </p:spPr>
        <p:txBody>
          <a:bodyPr/>
          <a:lstStyle>
            <a:lvl1pPr marL="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1pPr>
            <a:lvl2pPr marL="27432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548640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3pPr>
            <a:lvl4pPr marL="8229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4pPr>
            <a:lvl5pPr marL="109728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5pPr>
            <a:lvl6pPr marL="137160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6pPr>
            <a:lvl7pPr marL="164592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7pPr>
            <a:lvl8pPr marL="192024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8pPr>
            <a:lvl9pPr marL="21945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42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1217083"/>
            <a:ext cx="3108960" cy="29008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1217083"/>
            <a:ext cx="3108960" cy="29008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926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243417"/>
            <a:ext cx="6309360" cy="8837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3" y="1120775"/>
            <a:ext cx="3094672" cy="549275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3" y="1670050"/>
            <a:ext cx="3094672" cy="2456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1120775"/>
            <a:ext cx="3109913" cy="549275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1670050"/>
            <a:ext cx="3109913" cy="2456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862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828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205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304800"/>
            <a:ext cx="2359342" cy="106680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658284"/>
            <a:ext cx="3703320" cy="3249083"/>
          </a:xfrm>
        </p:spPr>
        <p:txBody>
          <a:bodyPr/>
          <a:lstStyle>
            <a:lvl1pPr>
              <a:defRPr sz="1920"/>
            </a:lvl1pPr>
            <a:lvl2pPr>
              <a:defRPr sz="1680"/>
            </a:lvl2pPr>
            <a:lvl3pPr>
              <a:defRPr sz="144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1371600"/>
            <a:ext cx="2359342" cy="2541059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746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304800"/>
            <a:ext cx="2359342" cy="106680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658284"/>
            <a:ext cx="3703320" cy="3249083"/>
          </a:xfrm>
        </p:spPr>
        <p:txBody>
          <a:bodyPr anchor="t"/>
          <a:lstStyle>
            <a:lvl1pPr marL="0" indent="0">
              <a:buNone/>
              <a:defRPr sz="1920"/>
            </a:lvl1pPr>
            <a:lvl2pPr marL="274320" indent="0">
              <a:buNone/>
              <a:defRPr sz="1680"/>
            </a:lvl2pPr>
            <a:lvl3pPr marL="548640" indent="0">
              <a:buNone/>
              <a:defRPr sz="1440"/>
            </a:lvl3pPr>
            <a:lvl4pPr marL="822960" indent="0">
              <a:buNone/>
              <a:defRPr sz="1200"/>
            </a:lvl4pPr>
            <a:lvl5pPr marL="1097280" indent="0">
              <a:buNone/>
              <a:defRPr sz="1200"/>
            </a:lvl5pPr>
            <a:lvl6pPr marL="1371600" indent="0">
              <a:buNone/>
              <a:defRPr sz="1200"/>
            </a:lvl6pPr>
            <a:lvl7pPr marL="1645920" indent="0">
              <a:buNone/>
              <a:defRPr sz="1200"/>
            </a:lvl7pPr>
            <a:lvl8pPr marL="1920240" indent="0">
              <a:buNone/>
              <a:defRPr sz="1200"/>
            </a:lvl8pPr>
            <a:lvl9pPr marL="2194560" indent="0">
              <a:buNone/>
              <a:defRPr sz="1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1371600"/>
            <a:ext cx="2359342" cy="2541059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282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243417"/>
            <a:ext cx="6309360" cy="8837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217083"/>
            <a:ext cx="6309360" cy="29008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4237567"/>
            <a:ext cx="164592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4237567"/>
            <a:ext cx="246888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4237567"/>
            <a:ext cx="164592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226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48640" rtl="0" eaLnBrk="1" latinLnBrk="0" hangingPunct="1">
        <a:lnSpc>
          <a:spcPct val="90000"/>
        </a:lnSpc>
        <a:spcBef>
          <a:spcPct val="0"/>
        </a:spcBef>
        <a:buNone/>
        <a:defRPr sz="26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7160" indent="-137160" algn="l" defTabSz="54864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23444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50876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7830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20574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3317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1pPr>
      <a:lvl2pPr marL="2743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2pPr>
      <a:lvl3pPr marL="5486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3pPr>
      <a:lvl4pPr marL="8229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09728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37160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6459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19202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1945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703811" y="282633"/>
            <a:ext cx="5979622" cy="4289367"/>
            <a:chOff x="149051" y="258398"/>
            <a:chExt cx="7851869" cy="6172547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987D37F9-9691-406E-86B6-45BB450A826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90853" y="627731"/>
              <a:ext cx="6984581" cy="2467162"/>
            </a:xfrm>
            <a:prstGeom prst="rect">
              <a:avLst/>
            </a:prstGeom>
          </p:spPr>
        </p:pic>
        <p:pic>
          <p:nvPicPr>
            <p:cNvPr id="4" name="Picture 3" descr="A picture containing screenshot&#10;&#10;Description automatically generated">
              <a:extLst>
                <a:ext uri="{FF2B5EF4-FFF2-40B4-BE49-F238E27FC236}">
                  <a16:creationId xmlns:a16="http://schemas.microsoft.com/office/drawing/2014/main" id="{6F52A77E-2095-43D6-A04C-787C451161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30" t="5220" b="34119"/>
            <a:stretch/>
          </p:blipFill>
          <p:spPr>
            <a:xfrm>
              <a:off x="149051" y="3479242"/>
              <a:ext cx="7851869" cy="2951703"/>
            </a:xfrm>
            <a:prstGeom prst="rect">
              <a:avLst/>
            </a:prstGeom>
          </p:spPr>
        </p:pic>
        <p:pic>
          <p:nvPicPr>
            <p:cNvPr id="5" name="Picture 4" descr="A close up of a sign&#10;&#10;Description automatically generated">
              <a:extLst>
                <a:ext uri="{FF2B5EF4-FFF2-40B4-BE49-F238E27FC236}">
                  <a16:creationId xmlns:a16="http://schemas.microsoft.com/office/drawing/2014/main" id="{AD702E64-0D96-486D-9CAA-C7E38A9B6B3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3" t="8034" r="2083" b="4825"/>
            <a:stretch/>
          </p:blipFill>
          <p:spPr>
            <a:xfrm>
              <a:off x="2563931" y="2482763"/>
              <a:ext cx="2044932" cy="612130"/>
            </a:xfrm>
            <a:prstGeom prst="rect">
              <a:avLst/>
            </a:prstGeom>
          </p:spPr>
        </p:pic>
        <p:pic>
          <p:nvPicPr>
            <p:cNvPr id="6" name="Picture 5" descr="A close up of a sign&#10;&#10;Description automatically generated">
              <a:extLst>
                <a:ext uri="{FF2B5EF4-FFF2-40B4-BE49-F238E27FC236}">
                  <a16:creationId xmlns:a16="http://schemas.microsoft.com/office/drawing/2014/main" id="{770A416D-5FCD-4ED9-8A69-37C7ADDE822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28" t="7691" r="4157" b="6346"/>
            <a:stretch/>
          </p:blipFill>
          <p:spPr>
            <a:xfrm>
              <a:off x="5987022" y="2482763"/>
              <a:ext cx="786938" cy="612130"/>
            </a:xfrm>
            <a:prstGeom prst="rect">
              <a:avLst/>
            </a:prstGeom>
          </p:spPr>
        </p:pic>
        <p:pic>
          <p:nvPicPr>
            <p:cNvPr id="7" name="Picture 6" descr="A picture containing fence&#10;&#10;Description automatically generated">
              <a:extLst>
                <a:ext uri="{FF2B5EF4-FFF2-40B4-BE49-F238E27FC236}">
                  <a16:creationId xmlns:a16="http://schemas.microsoft.com/office/drawing/2014/main" id="{C1488366-8DE1-4F52-9EC4-9D5FA1CF483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29" t="7594" r="3862" b="6444"/>
            <a:stretch/>
          </p:blipFill>
          <p:spPr>
            <a:xfrm>
              <a:off x="4751622" y="2482764"/>
              <a:ext cx="881150" cy="612130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2DCF141-4DA2-4971-9C3B-60B8EA6DAF81}"/>
                </a:ext>
              </a:extLst>
            </p:cNvPr>
            <p:cNvSpPr txBox="1"/>
            <p:nvPr/>
          </p:nvSpPr>
          <p:spPr>
            <a:xfrm>
              <a:off x="149051" y="258398"/>
              <a:ext cx="3593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a.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BB91CAE6-238F-4A28-8505-A754F76316A6}"/>
                </a:ext>
              </a:extLst>
            </p:cNvPr>
            <p:cNvSpPr txBox="1"/>
            <p:nvPr/>
          </p:nvSpPr>
          <p:spPr>
            <a:xfrm>
              <a:off x="149051" y="3490909"/>
              <a:ext cx="36901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b.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B991D1FC-4A47-43E2-A477-3EA105592A11}"/>
              </a:ext>
            </a:extLst>
          </p:cNvPr>
          <p:cNvSpPr txBox="1"/>
          <p:nvPr/>
        </p:nvSpPr>
        <p:spPr>
          <a:xfrm>
            <a:off x="180976" y="8362"/>
            <a:ext cx="691515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8: </a:t>
            </a: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Analysis of aging-related plasma exosome miRNA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. (a) The motives of significantly altered miRNAs (B) heat map of significantly altered miRNA across the sample.</a:t>
            </a:r>
            <a:endParaRPr lang="en-IN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09625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17</TotalTime>
  <Words>36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dip Patel</dc:creator>
  <cp:lastModifiedBy>Sandip</cp:lastModifiedBy>
  <cp:revision>245</cp:revision>
  <dcterms:created xsi:type="dcterms:W3CDTF">2020-03-03T17:34:57Z</dcterms:created>
  <dcterms:modified xsi:type="dcterms:W3CDTF">2020-12-25T06:18:57Z</dcterms:modified>
</cp:coreProperties>
</file>